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Volumes/Appetite/Papers%20in%20progress/CompRev%20paper/fMRI%20Wanting%20and%20Restraint%20results%2015%20May%202019%20AP%20new%20color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4719828301297"/>
          <c:y val="9.5253526814227704E-2"/>
          <c:w val="0.774460480414631"/>
          <c:h val="0.637840788518457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w May 2019 using 3 groups'!$T$32</c:f>
              <c:strCache>
                <c:ptCount val="1"/>
                <c:pt idx="0">
                  <c:v>Non-Stress</c:v>
                </c:pt>
              </c:strCache>
            </c:strRef>
          </c:tx>
          <c:spPr>
            <a:pattFill prst="dkUpDiag">
              <a:fgClr>
                <a:srgbClr val="FF40FF"/>
              </a:fgClr>
              <a:bgClr>
                <a:schemeClr val="bg1"/>
              </a:bgClr>
            </a:patt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1-3BB4-BB4E-9C78-35AC8BAC52C0}"/>
              </c:ext>
            </c:extLst>
          </c:dPt>
          <c:dPt>
            <c:idx val="1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3-3BB4-BB4E-9C78-35AC8BAC52C0}"/>
              </c:ext>
            </c:extLst>
          </c:dPt>
          <c:dPt>
            <c:idx val="2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5-3BB4-BB4E-9C78-35AC8BAC52C0}"/>
              </c:ext>
            </c:extLst>
          </c:dPt>
          <c:errBars>
            <c:errBarType val="both"/>
            <c:errValType val="cust"/>
            <c:noEndCap val="0"/>
            <c:plus>
              <c:numRef>
                <c:f>'new May 2019 using 3 groups'!$AA$32:$AF$32</c:f>
                <c:numCache>
                  <c:formatCode>General</c:formatCode>
                  <c:ptCount val="6"/>
                  <c:pt idx="0">
                    <c:v>12.391349999999999</c:v>
                  </c:pt>
                  <c:pt idx="1">
                    <c:v>4.9340799999999998</c:v>
                  </c:pt>
                  <c:pt idx="2">
                    <c:v>12.91714</c:v>
                  </c:pt>
                  <c:pt idx="3">
                    <c:v>8.2240900000000003</c:v>
                  </c:pt>
                  <c:pt idx="4">
                    <c:v>4.5421799999999974</c:v>
                  </c:pt>
                  <c:pt idx="5">
                    <c:v>8.5475900000000014</c:v>
                  </c:pt>
                </c:numCache>
              </c:numRef>
            </c:plus>
            <c:minus>
              <c:numRef>
                <c:f>'new May 2019 using 3 groups'!$AA$32:$AF$32</c:f>
                <c:numCache>
                  <c:formatCode>General</c:formatCode>
                  <c:ptCount val="6"/>
                  <c:pt idx="0">
                    <c:v>12.391349999999999</c:v>
                  </c:pt>
                  <c:pt idx="1">
                    <c:v>4.9340799999999998</c:v>
                  </c:pt>
                  <c:pt idx="2">
                    <c:v>12.91714</c:v>
                  </c:pt>
                  <c:pt idx="3">
                    <c:v>8.2240900000000003</c:v>
                  </c:pt>
                  <c:pt idx="4">
                    <c:v>4.5421799999999974</c:v>
                  </c:pt>
                  <c:pt idx="5">
                    <c:v>8.54759000000000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ew May 2019 using 3 groups'!$U$30:$Z$31</c:f>
              <c:multiLvlStrCache>
                <c:ptCount val="6"/>
                <c:lvl>
                  <c:pt idx="0">
                    <c:v>High-ED food</c:v>
                  </c:pt>
                  <c:pt idx="1">
                    <c:v>Low-ED food</c:v>
                  </c:pt>
                  <c:pt idx="2">
                    <c:v>Non-food</c:v>
                  </c:pt>
                  <c:pt idx="3">
                    <c:v>High-ED food</c:v>
                  </c:pt>
                  <c:pt idx="4">
                    <c:v>Low-ED food</c:v>
                  </c:pt>
                  <c:pt idx="5">
                    <c:v>Non-food</c:v>
                  </c:pt>
                </c:lvl>
                <c:lvl>
                  <c:pt idx="0">
                    <c:v>Obese Binge Eating (n=6)</c:v>
                  </c:pt>
                  <c:pt idx="3">
                    <c:v>Obese Non-Binge Eating (n=11)</c:v>
                  </c:pt>
                </c:lvl>
              </c:multiLvlStrCache>
            </c:multiLvlStrRef>
          </c:cat>
          <c:val>
            <c:numRef>
              <c:f>'new May 2019 using 3 groups'!$U$32:$Z$32</c:f>
              <c:numCache>
                <c:formatCode>General</c:formatCode>
                <c:ptCount val="6"/>
                <c:pt idx="0">
                  <c:v>46.269000000000013</c:v>
                </c:pt>
                <c:pt idx="1">
                  <c:v>17.406700000000001</c:v>
                </c:pt>
                <c:pt idx="2">
                  <c:v>22.9389</c:v>
                </c:pt>
                <c:pt idx="3">
                  <c:v>45.0139</c:v>
                </c:pt>
                <c:pt idx="4">
                  <c:v>24.389600000000002</c:v>
                </c:pt>
                <c:pt idx="5">
                  <c:v>33.41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BB4-BB4E-9C78-35AC8BAC52C0}"/>
            </c:ext>
          </c:extLst>
        </c:ser>
        <c:ser>
          <c:idx val="1"/>
          <c:order val="1"/>
          <c:tx>
            <c:strRef>
              <c:f>'new May 2019 using 3 groups'!$T$33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rgbClr val="FF40FF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932092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8-3BB4-BB4E-9C78-35AC8BAC52C0}"/>
              </c:ext>
            </c:extLst>
          </c:dPt>
          <c:dPt>
            <c:idx val="1"/>
            <c:invertIfNegative val="0"/>
            <c:bubble3D val="0"/>
            <c:spPr>
              <a:solidFill>
                <a:srgbClr val="932092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A-3BB4-BB4E-9C78-35AC8BAC52C0}"/>
              </c:ext>
            </c:extLst>
          </c:dPt>
          <c:dPt>
            <c:idx val="2"/>
            <c:invertIfNegative val="0"/>
            <c:bubble3D val="0"/>
            <c:spPr>
              <a:solidFill>
                <a:srgbClr val="932092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C-3BB4-BB4E-9C78-35AC8BAC52C0}"/>
              </c:ext>
            </c:extLst>
          </c:dPt>
          <c:errBars>
            <c:errBarType val="both"/>
            <c:errValType val="cust"/>
            <c:noEndCap val="0"/>
            <c:plus>
              <c:numRef>
                <c:f>'new May 2019 using 3 groups'!$AA$33:$AF$33</c:f>
                <c:numCache>
                  <c:formatCode>General</c:formatCode>
                  <c:ptCount val="6"/>
                  <c:pt idx="0">
                    <c:v>4.45303</c:v>
                  </c:pt>
                  <c:pt idx="1">
                    <c:v>5.9668099999999997</c:v>
                  </c:pt>
                  <c:pt idx="2">
                    <c:v>10.36885</c:v>
                  </c:pt>
                  <c:pt idx="3">
                    <c:v>8.6343099999999975</c:v>
                  </c:pt>
                  <c:pt idx="4">
                    <c:v>3.5691999999999999</c:v>
                  </c:pt>
                  <c:pt idx="5">
                    <c:v>7.4739800000000001</c:v>
                  </c:pt>
                </c:numCache>
              </c:numRef>
            </c:plus>
            <c:minus>
              <c:numRef>
                <c:f>'new May 2019 using 3 groups'!$AA$33:$AF$33</c:f>
                <c:numCache>
                  <c:formatCode>General</c:formatCode>
                  <c:ptCount val="6"/>
                  <c:pt idx="0">
                    <c:v>4.45303</c:v>
                  </c:pt>
                  <c:pt idx="1">
                    <c:v>5.9668099999999997</c:v>
                  </c:pt>
                  <c:pt idx="2">
                    <c:v>10.36885</c:v>
                  </c:pt>
                  <c:pt idx="3">
                    <c:v>8.6343099999999975</c:v>
                  </c:pt>
                  <c:pt idx="4">
                    <c:v>3.5691999999999999</c:v>
                  </c:pt>
                  <c:pt idx="5">
                    <c:v>7.47398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ew May 2019 using 3 groups'!$U$30:$Z$31</c:f>
              <c:multiLvlStrCache>
                <c:ptCount val="6"/>
                <c:lvl>
                  <c:pt idx="0">
                    <c:v>High-ED food</c:v>
                  </c:pt>
                  <c:pt idx="1">
                    <c:v>Low-ED food</c:v>
                  </c:pt>
                  <c:pt idx="2">
                    <c:v>Non-food</c:v>
                  </c:pt>
                  <c:pt idx="3">
                    <c:v>High-ED food</c:v>
                  </c:pt>
                  <c:pt idx="4">
                    <c:v>Low-ED food</c:v>
                  </c:pt>
                  <c:pt idx="5">
                    <c:v>Non-food</c:v>
                  </c:pt>
                </c:lvl>
                <c:lvl>
                  <c:pt idx="0">
                    <c:v>Obese Binge Eating (n=6)</c:v>
                  </c:pt>
                  <c:pt idx="3">
                    <c:v>Obese Non-Binge Eating (n=11)</c:v>
                  </c:pt>
                </c:lvl>
              </c:multiLvlStrCache>
            </c:multiLvlStrRef>
          </c:cat>
          <c:val>
            <c:numRef>
              <c:f>'new May 2019 using 3 groups'!$U$33:$Z$33</c:f>
              <c:numCache>
                <c:formatCode>General</c:formatCode>
                <c:ptCount val="6"/>
                <c:pt idx="0">
                  <c:v>35.3703</c:v>
                </c:pt>
                <c:pt idx="1">
                  <c:v>17.488699999999941</c:v>
                </c:pt>
                <c:pt idx="2">
                  <c:v>42.804699999999997</c:v>
                </c:pt>
                <c:pt idx="3">
                  <c:v>48.098400000000012</c:v>
                </c:pt>
                <c:pt idx="4">
                  <c:v>22.475000000000001</c:v>
                </c:pt>
                <c:pt idx="5">
                  <c:v>31.8083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BB4-BB4E-9C78-35AC8BAC52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764622112"/>
        <c:axId val="-1764715584"/>
      </c:barChart>
      <c:catAx>
        <c:axId val="-1764622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1764715584"/>
        <c:crosses val="autoZero"/>
        <c:auto val="1"/>
        <c:lblAlgn val="ctr"/>
        <c:lblOffset val="100"/>
        <c:tickLblSkip val="1"/>
        <c:noMultiLvlLbl val="0"/>
      </c:catAx>
      <c:valAx>
        <c:axId val="-1764715584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Restraint scores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1764622112"/>
        <c:crossesAt val="1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7644</cdr:x>
      <cdr:y>0.06594</cdr:y>
    </cdr:from>
    <cdr:to>
      <cdr:x>1</cdr:x>
      <cdr:y>0.16944</cdr:y>
    </cdr:to>
    <cdr:grpSp>
      <cdr:nvGrpSpPr>
        <cdr:cNvPr id="2" name="Group 1">
          <a:extLst xmlns:a="http://schemas.openxmlformats.org/drawingml/2006/main">
            <a:ext uri="{FF2B5EF4-FFF2-40B4-BE49-F238E27FC236}">
              <a16:creationId xmlns:a16="http://schemas.microsoft.com/office/drawing/2014/main" id="{A4E78444-95B7-F841-9DCD-71797483B094}"/>
            </a:ext>
          </a:extLst>
        </cdr:cNvPr>
        <cdr:cNvGrpSpPr/>
      </cdr:nvGrpSpPr>
      <cdr:grpSpPr>
        <a:xfrm xmlns:a="http://schemas.openxmlformats.org/drawingml/2006/main">
          <a:off x="4378190" y="252278"/>
          <a:ext cx="1260610" cy="395978"/>
          <a:chOff x="-4308902" y="-200926"/>
          <a:chExt cx="1260631" cy="395975"/>
        </a:xfrm>
      </cdr:grpSpPr>
      <cdr:pic>
        <cdr:nvPicPr>
          <cdr:cNvPr id="3" name="Picture 2">
            <a:extLst xmlns:a="http://schemas.openxmlformats.org/drawingml/2006/main">
              <a:ext uri="{FF2B5EF4-FFF2-40B4-BE49-F238E27FC236}">
                <a16:creationId xmlns:a16="http://schemas.microsoft.com/office/drawing/2014/main" id="{15925456-8467-4143-BA19-D04DDAF698C5}"/>
              </a:ext>
            </a:extLst>
          </cdr:cNvPr>
          <cdr:cNvPicPr/>
        </cdr:nvPicPr>
        <cdr:blipFill rotWithShape="1">
          <a:blip xmlns:a="http://schemas.openxmlformats.org/drawingml/2006/main"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xmlns:a="http://schemas.openxmlformats.org/drawingml/2006/main" l="39191"/>
          <a:stretch xmlns:a="http://schemas.openxmlformats.org/drawingml/2006/main"/>
        </cdr:blipFill>
        <cdr:spPr>
          <a:xfrm xmlns:a="http://schemas.openxmlformats.org/drawingml/2006/main">
            <a:off x="-3832656" y="-196785"/>
            <a:ext cx="784385" cy="391834"/>
          </a:xfrm>
          <a:prstGeom xmlns:a="http://schemas.openxmlformats.org/drawingml/2006/main" prst="rect">
            <a:avLst/>
          </a:prstGeom>
        </cdr:spPr>
      </cdr:pic>
      <cdr:pic>
        <cdr:nvPicPr>
          <cdr:cNvPr id="4" name="Picture 3">
            <a:extLst xmlns:a="http://schemas.openxmlformats.org/drawingml/2006/main">
              <a:ext uri="{FF2B5EF4-FFF2-40B4-BE49-F238E27FC236}">
                <a16:creationId xmlns:a16="http://schemas.microsoft.com/office/drawing/2014/main" id="{640907C8-BF73-074E-928A-AB3DF7325D09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2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-4307927" y="59212"/>
            <a:ext cx="135837" cy="135837"/>
          </a:xfrm>
          <a:prstGeom xmlns:a="http://schemas.openxmlformats.org/drawingml/2006/main" prst="rect">
            <a:avLst/>
          </a:prstGeom>
        </cdr:spPr>
      </cdr:pic>
      <cdr:pic>
        <cdr:nvPicPr>
          <cdr:cNvPr id="5" name="Picture 4">
            <a:extLst xmlns:a="http://schemas.openxmlformats.org/drawingml/2006/main">
              <a:ext uri="{FF2B5EF4-FFF2-40B4-BE49-F238E27FC236}">
                <a16:creationId xmlns:a16="http://schemas.microsoft.com/office/drawing/2014/main" id="{E7F5D5E2-A58D-C441-9C8D-1D8D493DAD9E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3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-4074516" y="-200926"/>
            <a:ext cx="142337" cy="134429"/>
          </a:xfrm>
          <a:prstGeom xmlns:a="http://schemas.openxmlformats.org/drawingml/2006/main" prst="rect">
            <a:avLst/>
          </a:prstGeom>
        </cdr:spPr>
      </cdr:pic>
      <cdr:pic>
        <cdr:nvPicPr>
          <cdr:cNvPr id="6" name="Picture 5">
            <a:extLst xmlns:a="http://schemas.openxmlformats.org/drawingml/2006/main">
              <a:ext uri="{FF2B5EF4-FFF2-40B4-BE49-F238E27FC236}">
                <a16:creationId xmlns:a16="http://schemas.microsoft.com/office/drawing/2014/main" id="{C27F5FE2-B8CF-E64F-90F8-B78E22BCD0CB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4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-4068016" y="57184"/>
            <a:ext cx="135837" cy="137865"/>
          </a:xfrm>
          <a:prstGeom xmlns:a="http://schemas.openxmlformats.org/drawingml/2006/main" prst="rect">
            <a:avLst/>
          </a:prstGeom>
        </cdr:spPr>
      </cdr:pic>
      <cdr:pic>
        <cdr:nvPicPr>
          <cdr:cNvPr id="7" name="Picture 6">
            <a:extLst xmlns:a="http://schemas.openxmlformats.org/drawingml/2006/main">
              <a:ext uri="{FF2B5EF4-FFF2-40B4-BE49-F238E27FC236}">
                <a16:creationId xmlns:a16="http://schemas.microsoft.com/office/drawing/2014/main" id="{E3B03624-B0D2-4042-984F-B9D4A611E9E2}"/>
              </a:ext>
            </a:extLst>
          </cdr:cNvPr>
          <cdr:cNvPicPr>
            <a:picLocks xmlns:a="http://schemas.openxmlformats.org/drawingml/2006/main" noChangeAspect="1"/>
          </cdr:cNvPicPr>
        </cdr:nvPicPr>
        <cdr:blipFill>
          <a:blip xmlns:a="http://schemas.openxmlformats.org/drawingml/2006/main" xmlns:r="http://schemas.openxmlformats.org/officeDocument/2006/relationships" r:embed="rId5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-4308902" y="-196785"/>
            <a:ext cx="135837" cy="137865"/>
          </a:xfrm>
          <a:prstGeom xmlns:a="http://schemas.openxmlformats.org/drawingml/2006/main" prst="rect">
            <a:avLst/>
          </a:prstGeom>
        </cdr:spPr>
      </cdr:pic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7: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Restraint scores for each cue type by binge eating sub-group and condition</a:t>
            </a:r>
            <a:r>
              <a:rPr lang="en-US" dirty="0">
                <a:effectLst/>
              </a:rPr>
              <a:t> </a:t>
            </a:r>
            <a:endParaRPr lang="en-US" sz="1200" kern="1200" dirty="0">
              <a:solidFill>
                <a:schemeClr val="tx1"/>
              </a:solidFill>
              <a:effectLst/>
              <a:latin typeface="Arial" pitchFamily="-106" charset="0"/>
              <a:ea typeface="ＭＳ Ｐゴシック" pitchFamily="-106" charset="-128"/>
              <a:cs typeface="ＭＳ Ｐゴシック" pitchFamily="-106" charset="-128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F0FE14C-31E7-4846-8655-2F062EBFACAF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11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9585882-5320-164C-B8F8-D43F4E1F55C5}"/>
              </a:ext>
            </a:extLst>
          </p:cNvPr>
          <p:cNvGraphicFramePr/>
          <p:nvPr/>
        </p:nvGraphicFramePr>
        <p:xfrm>
          <a:off x="3276600" y="1516062"/>
          <a:ext cx="5638800" cy="3825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816367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3</cp:revision>
  <dcterms:created xsi:type="dcterms:W3CDTF">2021-05-24T12:55:43Z</dcterms:created>
  <dcterms:modified xsi:type="dcterms:W3CDTF">2022-08-31T20:45:26Z</dcterms:modified>
</cp:coreProperties>
</file>